
<file path=[Content_Types].xml><?xml version="1.0" encoding="utf-8"?>
<Types xmlns="http://schemas.openxmlformats.org/package/2006/content-types"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16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71F56-2ED2-47BB-946E-E0BB9545552B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4E45-F84E-44C6-B684-5AF0296B1B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6333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71F56-2ED2-47BB-946E-E0BB9545552B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4E45-F84E-44C6-B684-5AF0296B1B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701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71F56-2ED2-47BB-946E-E0BB9545552B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4E45-F84E-44C6-B684-5AF0296B1B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9466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71F56-2ED2-47BB-946E-E0BB9545552B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4E45-F84E-44C6-B684-5AF0296B1B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822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71F56-2ED2-47BB-946E-E0BB9545552B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4E45-F84E-44C6-B684-5AF0296B1B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720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71F56-2ED2-47BB-946E-E0BB9545552B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4E45-F84E-44C6-B684-5AF0296B1B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70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71F56-2ED2-47BB-946E-E0BB9545552B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4E45-F84E-44C6-B684-5AF0296B1B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305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71F56-2ED2-47BB-946E-E0BB9545552B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4E45-F84E-44C6-B684-5AF0296B1B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434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71F56-2ED2-47BB-946E-E0BB9545552B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4E45-F84E-44C6-B684-5AF0296B1B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112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71F56-2ED2-47BB-946E-E0BB9545552B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4E45-F84E-44C6-B684-5AF0296B1B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1099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371F56-2ED2-47BB-946E-E0BB9545552B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C4E45-F84E-44C6-B684-5AF0296B1B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964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371F56-2ED2-47BB-946E-E0BB9545552B}" type="datetimeFigureOut">
              <a:rPr lang="en-US" smtClean="0"/>
              <a:t>10/22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9C4E45-F84E-44C6-B684-5AF0296B1B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47791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381000" y="762000"/>
            <a:ext cx="8382000" cy="5373624"/>
            <a:chOff x="381000" y="304800"/>
            <a:chExt cx="8382000" cy="5373624"/>
          </a:xfrm>
        </p:grpSpPr>
        <p:pic>
          <p:nvPicPr>
            <p:cNvPr id="1026" name="Picture 2" descr="D:\Southern Medical University\Zheng Ae albopictus\Maps\china 3.wmf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3644" b="4948"/>
            <a:stretch/>
          </p:blipFill>
          <p:spPr bwMode="auto">
            <a:xfrm>
              <a:off x="381000" y="304800"/>
              <a:ext cx="8259192" cy="531624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3152965" y="2180247"/>
              <a:ext cx="63671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nsu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058943" y="2827498"/>
              <a:ext cx="7120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Qinghai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728160" y="2833923"/>
              <a:ext cx="8819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andong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363187" y="2086096"/>
              <a:ext cx="11977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ner Mongoli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147389" y="645605"/>
              <a:ext cx="1154483" cy="10156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228600" indent="-228600">
                <a:buAutoNum type="arabicPeriod"/>
              </a:pP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ingxia</a:t>
              </a:r>
            </a:p>
            <a:p>
              <a:pPr marL="228600" indent="-228600">
                <a:buAutoNum type="arabicPeriod"/>
              </a:pP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eijing</a:t>
              </a:r>
            </a:p>
            <a:p>
              <a:pPr marL="228600" indent="-228600">
                <a:buAutoNum type="arabicPeriod"/>
              </a:pP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anjin</a:t>
              </a:r>
            </a:p>
            <a:p>
              <a:pPr marL="228600" indent="-228600">
                <a:buAutoNum type="arabicPeriod"/>
              </a:pP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ongqing</a:t>
              </a:r>
            </a:p>
            <a:p>
              <a:pPr marL="228600" indent="-228600">
                <a:buAutoNum type="arabicPeriod"/>
              </a:pP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ujia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647177" y="2658967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790854" y="2017705"/>
              <a:ext cx="7280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injiang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029114" y="3493050"/>
              <a:ext cx="5203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bet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933892" y="3586073"/>
              <a:ext cx="7377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chua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812323" y="4477364"/>
              <a:ext cx="7035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unna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527236" y="4194387"/>
              <a:ext cx="7553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uizhou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767430" y="4608523"/>
              <a:ext cx="7553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uangxi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856043" y="2864525"/>
              <a:ext cx="737702" cy="276999"/>
            </a:xfrm>
            <a:prstGeom prst="rect">
              <a:avLst/>
            </a:prstGeom>
            <a:noFill/>
            <a:scene3d>
              <a:camera prst="orthographicFront">
                <a:rot lat="0" lon="0" rev="5400000"/>
              </a:camera>
              <a:lightRig rig="threePt" dir="t"/>
            </a:scene3d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aanxi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025784" y="2214661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167238" y="232357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851127" y="370611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7287446" y="1185224"/>
              <a:ext cx="10246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ilongjiang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305734" y="1701227"/>
              <a:ext cx="4475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il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648902" y="1996749"/>
              <a:ext cx="7617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aoning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276184" y="2611581"/>
              <a:ext cx="652743" cy="276999"/>
            </a:xfrm>
            <a:prstGeom prst="rect">
              <a:avLst/>
            </a:prstGeom>
            <a:noFill/>
            <a:scene3d>
              <a:camera prst="orthographicFront">
                <a:rot lat="0" lon="0" rev="5400000"/>
              </a:camera>
              <a:lightRig rig="threePt" dir="t"/>
            </a:scene3d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anxi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688621" y="2463035"/>
              <a:ext cx="583814" cy="276999"/>
            </a:xfrm>
            <a:prstGeom prst="rect">
              <a:avLst/>
            </a:prstGeom>
            <a:noFill/>
            <a:scene3d>
              <a:camera prst="orthographicFront">
                <a:rot lat="0" lon="0" rev="5400000"/>
              </a:camera>
              <a:lightRig rig="threePt" dir="t"/>
            </a:scene3d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bei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441464" y="3152462"/>
              <a:ext cx="6351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ena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364788" y="3558542"/>
              <a:ext cx="583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ubei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6210235" y="4389852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5224894" y="3998455"/>
              <a:ext cx="6351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una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720865" y="4071174"/>
              <a:ext cx="660758" cy="276999"/>
            </a:xfrm>
            <a:prstGeom prst="rect">
              <a:avLst/>
            </a:prstGeom>
            <a:noFill/>
            <a:scene3d>
              <a:camera prst="orthographicFront">
                <a:rot lat="0" lon="0" rev="5400000"/>
              </a:camera>
              <a:lightRig rig="threePt" dir="t"/>
            </a:scene3d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iangxi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970701" y="3445268"/>
              <a:ext cx="575799" cy="276999"/>
            </a:xfrm>
            <a:prstGeom prst="rect">
              <a:avLst/>
            </a:prstGeom>
            <a:noFill/>
            <a:scene3d>
              <a:camera prst="orthographicFront">
                <a:rot lat="0" lon="0" rev="5400000"/>
              </a:camera>
              <a:lightRig rig="threePt" dir="t"/>
            </a:scene3d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hui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6677838" y="3203215"/>
              <a:ext cx="7120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Jiangsu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6837451" y="3922447"/>
              <a:ext cx="7713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Zhejiang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6778250" y="4720856"/>
              <a:ext cx="6613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aiwa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627146" y="4990991"/>
              <a:ext cx="9845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uangdong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365083" y="5334000"/>
              <a:ext cx="6687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aina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0" name="Picture 39"/>
            <p:cNvPicPr>
              <a:picLocks noChangeAspect="1"/>
            </p:cNvPicPr>
            <p:nvPr/>
          </p:nvPicPr>
          <p:blipFill rotWithShape="1">
            <a:blip r:embed="rId3"/>
            <a:srcRect r="3432" b="1480"/>
            <a:stretch/>
          </p:blipFill>
          <p:spPr>
            <a:xfrm>
              <a:off x="7606124" y="3885402"/>
              <a:ext cx="1156876" cy="179302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" name="Rectangle 1"/>
            <p:cNvSpPr/>
            <p:nvPr/>
          </p:nvSpPr>
          <p:spPr>
            <a:xfrm>
              <a:off x="381000" y="304800"/>
              <a:ext cx="8382000" cy="537362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4026520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37</Words>
  <Application>Microsoft Office PowerPoint</Application>
  <PresentationFormat>On-screen Show (4:3)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, Guofa</dc:creator>
  <cp:lastModifiedBy>Zhou, Guofa</cp:lastModifiedBy>
  <cp:revision>6</cp:revision>
  <dcterms:created xsi:type="dcterms:W3CDTF">2017-12-16T21:07:24Z</dcterms:created>
  <dcterms:modified xsi:type="dcterms:W3CDTF">2019-10-22T21:59:28Z</dcterms:modified>
</cp:coreProperties>
</file>